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83400" cy="100155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83200" cy="1001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82960" cy="50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97360" y="-360"/>
            <a:ext cx="2982960" cy="50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38160" y="750600"/>
            <a:ext cx="5006880" cy="3755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8680" y="4757400"/>
            <a:ext cx="5505480" cy="450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512280"/>
            <a:ext cx="2982960" cy="50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97360" y="9512280"/>
            <a:ext cx="2982960" cy="50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9627E0-B775-497D-BF0D-071A6CBB3C02}" type="slidenum">
              <a:rPr b="0" lang="en-CA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938160" y="750960"/>
            <a:ext cx="5006880" cy="375588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8680" y="4757400"/>
            <a:ext cx="5505480" cy="450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CA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lide Number Placeholder 3"/>
          <p:cNvSpPr/>
          <p:nvPr/>
        </p:nvSpPr>
        <p:spPr>
          <a:xfrm>
            <a:off x="3897360" y="9512280"/>
            <a:ext cx="2982960" cy="50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BF5829-9088-40A6-8369-2E4CCAA51B54}" type="slidenum">
              <a:rPr b="0" lang="en-CA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77EB8-86FD-4BD0-ADC3-DC16BB7141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205E2-37D3-48FB-8B73-80CF58CA22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DA1A7-A51B-4A96-88EC-D76DCFBB32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E7BC5-56B5-4F64-B83A-788A286A60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FE57F-8A57-4A99-A59E-EA852BFEA4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D2157-AC02-4684-90C6-E6516FA171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A2FB5-E2FD-446F-8B9A-F65EC17DD6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4AB87-8677-4299-9B13-1F230AB43E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7A7F1-FEC6-429F-B576-FAAC38383A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33BE4-6ACE-4E76-B71D-71C80B9C23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939BE-5EBF-4E7C-9507-07E1ADE94C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58C1B-00D7-4D48-BEDD-1A2F391C3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227D35-2529-4AE3-A581-DCCA8D025D9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3780360" y="439416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[Palmitate] (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µ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ct 5"/>
          <p:cNvGraphicFramePr/>
          <p:nvPr/>
        </p:nvGraphicFramePr>
        <p:xfrm>
          <a:off x="2230560" y="2025720"/>
          <a:ext cx="4892400" cy="2427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0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30560" y="2025720"/>
                    <a:ext cx="4892400" cy="242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Rectangle 6"/>
          <p:cNvSpPr/>
          <p:nvPr/>
        </p:nvSpPr>
        <p:spPr>
          <a:xfrm>
            <a:off x="6076800" y="2143080"/>
            <a:ext cx="314640" cy="78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"/>
          <p:cNvSpPr/>
          <p:nvPr/>
        </p:nvSpPr>
        <p:spPr>
          <a:xfrm>
            <a:off x="6095880" y="2333520"/>
            <a:ext cx="247680" cy="15264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8"/>
          <p:cNvSpPr/>
          <p:nvPr/>
        </p:nvSpPr>
        <p:spPr>
          <a:xfrm>
            <a:off x="6105600" y="2581200"/>
            <a:ext cx="247680" cy="1526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"/>
          <p:cNvSpPr/>
          <p:nvPr/>
        </p:nvSpPr>
        <p:spPr>
          <a:xfrm>
            <a:off x="144000" y="189000"/>
            <a:ext cx="12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1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"/>
          <p:cNvSpPr/>
          <p:nvPr/>
        </p:nvSpPr>
        <p:spPr>
          <a:xfrm>
            <a:off x="-24120" y="6216480"/>
            <a:ext cx="791640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ifert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et 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ong-chain fatty acid combustion rate is associated with unique metabolite profiles in skeletal muscle mitochond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4T01:51:08Z</dcterms:created>
  <dc:creator>Veronic Bezaire</dc:creator>
  <dc:description/>
  <dc:language>en-US</dc:language>
  <cp:lastModifiedBy>Erin</cp:lastModifiedBy>
  <dcterms:modified xsi:type="dcterms:W3CDTF">2010-03-04T18:45:23Z</dcterms:modified>
  <cp:revision>117</cp:revision>
  <dc:subject/>
  <dc:title>Slide 1</dc:title>
</cp:coreProperties>
</file>